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0"/>
  </p:notesMasterIdLst>
  <p:handoutMasterIdLst>
    <p:handoutMasterId r:id="rId11"/>
  </p:handoutMasterIdLst>
  <p:sldIdLst>
    <p:sldId id="273" r:id="rId5"/>
    <p:sldId id="305" r:id="rId6"/>
    <p:sldId id="288" r:id="rId7"/>
    <p:sldId id="282" r:id="rId8"/>
    <p:sldId id="307" r:id="rId9"/>
  </p:sldIdLst>
  <p:sldSz cx="7315200" cy="105156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ul-McBeth, Jessica" initials="SMJ" lastIdx="9" clrIdx="0"/>
  <p:cmAuthor id="2" name="Conti, Heather Raquel" initials="CR" lastIdx="1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5A9FF"/>
    <a:srgbClr val="76D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000000-0000-0000-0000-000000000000}" v="114" dt="2021-05-17T17:49:29.486"/>
    <p1510:client id="{4EE921F2-C071-4121-A917-F422E500ACAB}" v="1" vWet="3" dt="2021-05-17T17:39:36.518"/>
    <p1510:client id="{FDA977FC-D54B-090C-81AF-0144A439BAFD}" v="68" dt="2021-05-18T10:56:11.34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61"/>
  </p:normalViewPr>
  <p:slideViewPr>
    <p:cSldViewPr snapToGrid="0">
      <p:cViewPr>
        <p:scale>
          <a:sx n="1" d="2"/>
          <a:sy n="1" d="2"/>
        </p:scale>
        <p:origin x="5664" y="2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handoutMaster" Target="handoutMasters/handoutMaster1.xml"/><Relationship Id="rId12" Type="http://schemas.openxmlformats.org/officeDocument/2006/relationships/commentAuthors" Target="commentAuthors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7" Type="http://schemas.microsoft.com/office/2016/11/relationships/changesInfo" Target="changesInfos/changesInfo1.xml"/><Relationship Id="rId18" Type="http://schemas.microsoft.com/office/2015/10/relationships/revisionInfo" Target="revisionInfo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ul-McBeth, Jessica" userId="2a9720c8-3726-4b52-b390-59c1ca199c1c" providerId="ADAL" clId="{4EE921F2-C071-4121-A917-F422E500ACAB}"/>
    <pc:docChg chg="custSel addSld delSld modSld">
      <pc:chgData name="Saul-McBeth, Jessica" userId="2a9720c8-3726-4b52-b390-59c1ca199c1c" providerId="ADAL" clId="{4EE921F2-C071-4121-A917-F422E500ACAB}" dt="2021-05-17T17:13:07.837" v="49" actId="478"/>
      <pc:docMkLst>
        <pc:docMk/>
      </pc:docMkLst>
      <pc:sldChg chg="modSp mod">
        <pc:chgData name="Saul-McBeth, Jessica" userId="2a9720c8-3726-4b52-b390-59c1ca199c1c" providerId="ADAL" clId="{4EE921F2-C071-4121-A917-F422E500ACAB}" dt="2021-05-17T17:12:51.345" v="11" actId="20577"/>
        <pc:sldMkLst>
          <pc:docMk/>
          <pc:sldMk cId="2532921002" sldId="282"/>
        </pc:sldMkLst>
        <pc:spChg chg="mod">
          <ac:chgData name="Saul-McBeth, Jessica" userId="2a9720c8-3726-4b52-b390-59c1ca199c1c" providerId="ADAL" clId="{4EE921F2-C071-4121-A917-F422E500ACAB}" dt="2021-05-17T17:12:16.843" v="3" actId="20577"/>
          <ac:spMkLst>
            <pc:docMk/>
            <pc:sldMk cId="2532921002" sldId="282"/>
            <ac:spMk id="8" creationId="{EF84EE54-500F-1741-8410-E1E558FE0F6B}"/>
          </ac:spMkLst>
        </pc:spChg>
        <pc:spChg chg="mod">
          <ac:chgData name="Saul-McBeth, Jessica" userId="2a9720c8-3726-4b52-b390-59c1ca199c1c" providerId="ADAL" clId="{4EE921F2-C071-4121-A917-F422E500ACAB}" dt="2021-05-17T17:12:51.345" v="11" actId="20577"/>
          <ac:spMkLst>
            <pc:docMk/>
            <pc:sldMk cId="2532921002" sldId="282"/>
            <ac:spMk id="9" creationId="{35626C54-69E7-4FC0-9B95-59F10617F092}"/>
          </ac:spMkLst>
        </pc:spChg>
      </pc:sldChg>
      <pc:sldChg chg="new del">
        <pc:chgData name="Saul-McBeth, Jessica" userId="2a9720c8-3726-4b52-b390-59c1ca199c1c" providerId="ADAL" clId="{4EE921F2-C071-4121-A917-F422E500ACAB}" dt="2021-05-17T17:12:36.083" v="6" actId="47"/>
        <pc:sldMkLst>
          <pc:docMk/>
          <pc:sldMk cId="1359035113" sldId="306"/>
        </pc:sldMkLst>
      </pc:sldChg>
      <pc:sldChg chg="delSp modSp add mod">
        <pc:chgData name="Saul-McBeth, Jessica" userId="2a9720c8-3726-4b52-b390-59c1ca199c1c" providerId="ADAL" clId="{4EE921F2-C071-4121-A917-F422E500ACAB}" dt="2021-05-17T17:13:07.837" v="49" actId="478"/>
        <pc:sldMkLst>
          <pc:docMk/>
          <pc:sldMk cId="2786983650" sldId="307"/>
        </pc:sldMkLst>
        <pc:spChg chg="del">
          <ac:chgData name="Saul-McBeth, Jessica" userId="2a9720c8-3726-4b52-b390-59c1ca199c1c" providerId="ADAL" clId="{4EE921F2-C071-4121-A917-F422E500ACAB}" dt="2021-05-17T17:13:07.837" v="49" actId="478"/>
          <ac:spMkLst>
            <pc:docMk/>
            <pc:sldMk cId="2786983650" sldId="307"/>
            <ac:spMk id="7" creationId="{A1BC9187-2EDF-9446-BAA8-2C1E2CFE1562}"/>
          </ac:spMkLst>
        </pc:spChg>
        <pc:spChg chg="mod">
          <ac:chgData name="Saul-McBeth, Jessica" userId="2a9720c8-3726-4b52-b390-59c1ca199c1c" providerId="ADAL" clId="{4EE921F2-C071-4121-A917-F422E500ACAB}" dt="2021-05-17T17:13:05.367" v="48" actId="20577"/>
          <ac:spMkLst>
            <pc:docMk/>
            <pc:sldMk cId="2786983650" sldId="307"/>
            <ac:spMk id="8" creationId="{EF84EE54-500F-1741-8410-E1E558FE0F6B}"/>
          </ac:spMkLst>
        </pc:spChg>
        <pc:spChg chg="mod">
          <ac:chgData name="Saul-McBeth, Jessica" userId="2a9720c8-3726-4b52-b390-59c1ca199c1c" providerId="ADAL" clId="{4EE921F2-C071-4121-A917-F422E500ACAB}" dt="2021-05-17T17:12:47.823" v="10" actId="20577"/>
          <ac:spMkLst>
            <pc:docMk/>
            <pc:sldMk cId="2786983650" sldId="307"/>
            <ac:spMk id="9" creationId="{35626C54-69E7-4FC0-9B95-59F10617F092}"/>
          </ac:spMkLst>
        </pc:spChg>
        <pc:graphicFrameChg chg="del">
          <ac:chgData name="Saul-McBeth, Jessica" userId="2a9720c8-3726-4b52-b390-59c1ca199c1c" providerId="ADAL" clId="{4EE921F2-C071-4121-A917-F422E500ACAB}" dt="2021-05-17T17:12:38.419" v="7" actId="478"/>
          <ac:graphicFrameMkLst>
            <pc:docMk/>
            <pc:sldMk cId="2786983650" sldId="307"/>
            <ac:graphicFrameMk id="6" creationId="{18C37FE8-F0AF-B341-BB8A-47679E5659EA}"/>
          </ac:graphicFrameMkLst>
        </pc:graphicFrameChg>
      </pc:sldChg>
    </pc:docChg>
  </pc:docChgLst>
  <pc:docChgLst>
    <pc:chgData name="Conti, Heather Raquel" userId="S::hconti@rockets.utoledo.edu::1c655cd8-4db5-4252-b1b1-edb1a2bdeaae" providerId="AD" clId="Web-{00000000-0000-0000-0000-000000000000}"/>
    <pc:docChg chg="modSld">
      <pc:chgData name="Conti, Heather Raquel" userId="S::hconti@rockets.utoledo.edu::1c655cd8-4db5-4252-b1b1-edb1a2bdeaae" providerId="AD" clId="Web-{00000000-0000-0000-0000-000000000000}" dt="2021-05-17T17:49:28.048" v="49" actId="20577"/>
      <pc:docMkLst>
        <pc:docMk/>
      </pc:docMkLst>
      <pc:sldChg chg="delSp">
        <pc:chgData name="Conti, Heather Raquel" userId="S::hconti@rockets.utoledo.edu::1c655cd8-4db5-4252-b1b1-edb1a2bdeaae" providerId="AD" clId="Web-{00000000-0000-0000-0000-000000000000}" dt="2021-05-17T17:37:59.995" v="1"/>
        <pc:sldMkLst>
          <pc:docMk/>
          <pc:sldMk cId="221266015" sldId="273"/>
        </pc:sldMkLst>
        <pc:spChg chg="del">
          <ac:chgData name="Conti, Heather Raquel" userId="S::hconti@rockets.utoledo.edu::1c655cd8-4db5-4252-b1b1-edb1a2bdeaae" providerId="AD" clId="Web-{00000000-0000-0000-0000-000000000000}" dt="2021-05-17T17:37:59.995" v="1"/>
          <ac:spMkLst>
            <pc:docMk/>
            <pc:sldMk cId="221266015" sldId="273"/>
            <ac:spMk id="23" creationId="{DC6CF93B-35B0-4A01-BA49-88AEF2DD5A8D}"/>
          </ac:spMkLst>
        </pc:spChg>
      </pc:sldChg>
      <pc:sldChg chg="modSp">
        <pc:chgData name="Conti, Heather Raquel" userId="S::hconti@rockets.utoledo.edu::1c655cd8-4db5-4252-b1b1-edb1a2bdeaae" providerId="AD" clId="Web-{00000000-0000-0000-0000-000000000000}" dt="2021-05-17T17:49:28.048" v="49" actId="20577"/>
        <pc:sldMkLst>
          <pc:docMk/>
          <pc:sldMk cId="2532921002" sldId="282"/>
        </pc:sldMkLst>
        <pc:spChg chg="mod">
          <ac:chgData name="Conti, Heather Raquel" userId="S::hconti@rockets.utoledo.edu::1c655cd8-4db5-4252-b1b1-edb1a2bdeaae" providerId="AD" clId="Web-{00000000-0000-0000-0000-000000000000}" dt="2021-05-17T17:49:28.048" v="49" actId="20577"/>
          <ac:spMkLst>
            <pc:docMk/>
            <pc:sldMk cId="2532921002" sldId="282"/>
            <ac:spMk id="9" creationId="{35626C54-69E7-4FC0-9B95-59F10617F092}"/>
          </ac:spMkLst>
        </pc:spChg>
      </pc:sldChg>
      <pc:sldChg chg="delSp">
        <pc:chgData name="Conti, Heather Raquel" userId="S::hconti@rockets.utoledo.edu::1c655cd8-4db5-4252-b1b1-edb1a2bdeaae" providerId="AD" clId="Web-{00000000-0000-0000-0000-000000000000}" dt="2021-05-17T17:38:08.479" v="2"/>
        <pc:sldMkLst>
          <pc:docMk/>
          <pc:sldMk cId="1863755979" sldId="288"/>
        </pc:sldMkLst>
        <pc:spChg chg="del">
          <ac:chgData name="Conti, Heather Raquel" userId="S::hconti@rockets.utoledo.edu::1c655cd8-4db5-4252-b1b1-edb1a2bdeaae" providerId="AD" clId="Web-{00000000-0000-0000-0000-000000000000}" dt="2021-05-17T17:38:08.479" v="2"/>
          <ac:spMkLst>
            <pc:docMk/>
            <pc:sldMk cId="1863755979" sldId="288"/>
            <ac:spMk id="32" creationId="{82869809-9E1D-4208-8ADE-22990AC820EE}"/>
          </ac:spMkLst>
        </pc:spChg>
      </pc:sldChg>
      <pc:sldChg chg="delSp">
        <pc:chgData name="Conti, Heather Raquel" userId="S::hconti@rockets.utoledo.edu::1c655cd8-4db5-4252-b1b1-edb1a2bdeaae" providerId="AD" clId="Web-{00000000-0000-0000-0000-000000000000}" dt="2021-05-17T17:37:53.760" v="0"/>
        <pc:sldMkLst>
          <pc:docMk/>
          <pc:sldMk cId="1840551632" sldId="305"/>
        </pc:sldMkLst>
        <pc:spChg chg="del">
          <ac:chgData name="Conti, Heather Raquel" userId="S::hconti@rockets.utoledo.edu::1c655cd8-4db5-4252-b1b1-edb1a2bdeaae" providerId="AD" clId="Web-{00000000-0000-0000-0000-000000000000}" dt="2021-05-17T17:37:53.760" v="0"/>
          <ac:spMkLst>
            <pc:docMk/>
            <pc:sldMk cId="1840551632" sldId="305"/>
            <ac:spMk id="2" creationId="{00000000-0000-0000-0000-000000000000}"/>
          </ac:spMkLst>
        </pc:spChg>
      </pc:sldChg>
      <pc:sldChg chg="addSp modSp">
        <pc:chgData name="Conti, Heather Raquel" userId="S::hconti@rockets.utoledo.edu::1c655cd8-4db5-4252-b1b1-edb1a2bdeaae" providerId="AD" clId="Web-{00000000-0000-0000-0000-000000000000}" dt="2021-05-17T17:49:23.564" v="48" actId="20577"/>
        <pc:sldMkLst>
          <pc:docMk/>
          <pc:sldMk cId="2786983650" sldId="307"/>
        </pc:sldMkLst>
        <pc:spChg chg="add mod">
          <ac:chgData name="Conti, Heather Raquel" userId="S::hconti@rockets.utoledo.edu::1c655cd8-4db5-4252-b1b1-edb1a2bdeaae" providerId="AD" clId="Web-{00000000-0000-0000-0000-000000000000}" dt="2021-05-17T17:49:01.563" v="46" actId="20577"/>
          <ac:spMkLst>
            <pc:docMk/>
            <pc:sldMk cId="2786983650" sldId="307"/>
            <ac:spMk id="4" creationId="{0C37392C-B45D-40C8-A45D-41E42449897F}"/>
          </ac:spMkLst>
        </pc:spChg>
        <pc:spChg chg="mod">
          <ac:chgData name="Conti, Heather Raquel" userId="S::hconti@rockets.utoledo.edu::1c655cd8-4db5-4252-b1b1-edb1a2bdeaae" providerId="AD" clId="Web-{00000000-0000-0000-0000-000000000000}" dt="2021-05-17T17:49:23.564" v="48" actId="20577"/>
          <ac:spMkLst>
            <pc:docMk/>
            <pc:sldMk cId="2786983650" sldId="307"/>
            <ac:spMk id="9" creationId="{35626C54-69E7-4FC0-9B95-59F10617F092}"/>
          </ac:spMkLst>
        </pc:spChg>
        <pc:graphicFrameChg chg="add mod modGraphic">
          <ac:chgData name="Conti, Heather Raquel" userId="S::hconti@rockets.utoledo.edu::1c655cd8-4db5-4252-b1b1-edb1a2bdeaae" providerId="AD" clId="Web-{00000000-0000-0000-0000-000000000000}" dt="2021-05-17T17:47:41.201" v="18"/>
          <ac:graphicFrameMkLst>
            <pc:docMk/>
            <pc:sldMk cId="2786983650" sldId="307"/>
            <ac:graphicFrameMk id="3" creationId="{F95826C0-860C-45CE-A46B-3138B2775139}"/>
          </ac:graphicFrameMkLst>
        </pc:graphicFrameChg>
      </pc:sldChg>
    </pc:docChg>
  </pc:docChgLst>
  <pc:docChgLst>
    <pc:chgData name="Conti, Heather Raquel" userId="S::hconti@rockets.utoledo.edu::1c655cd8-4db5-4252-b1b1-edb1a2bdeaae" providerId="AD" clId="Web-{FDA977FC-D54B-090C-81AF-0144A439BAFD}"/>
    <pc:docChg chg="modSld">
      <pc:chgData name="Conti, Heather Raquel" userId="S::hconti@rockets.utoledo.edu::1c655cd8-4db5-4252-b1b1-edb1a2bdeaae" providerId="AD" clId="Web-{FDA977FC-D54B-090C-81AF-0144A439BAFD}" dt="2021-05-18T10:56:11.345" v="67"/>
      <pc:docMkLst>
        <pc:docMk/>
      </pc:docMkLst>
      <pc:sldChg chg="modSp">
        <pc:chgData name="Conti, Heather Raquel" userId="S::hconti@rockets.utoledo.edu::1c655cd8-4db5-4252-b1b1-edb1a2bdeaae" providerId="AD" clId="Web-{FDA977FC-D54B-090C-81AF-0144A439BAFD}" dt="2021-05-18T10:56:11.345" v="67"/>
        <pc:sldMkLst>
          <pc:docMk/>
          <pc:sldMk cId="2532921002" sldId="282"/>
        </pc:sldMkLst>
        <pc:graphicFrameChg chg="mod modGraphic">
          <ac:chgData name="Conti, Heather Raquel" userId="S::hconti@rockets.utoledo.edu::1c655cd8-4db5-4252-b1b1-edb1a2bdeaae" providerId="AD" clId="Web-{FDA977FC-D54B-090C-81AF-0144A439BAFD}" dt="2021-05-18T10:56:11.345" v="67"/>
          <ac:graphicFrameMkLst>
            <pc:docMk/>
            <pc:sldMk cId="2532921002" sldId="282"/>
            <ac:graphicFrameMk id="6" creationId="{18C37FE8-F0AF-B341-BB8A-47679E5659EA}"/>
          </ac:graphicFrameMkLst>
        </pc:graphicFrameChg>
      </pc:sldChg>
      <pc:sldChg chg="modSp">
        <pc:chgData name="Conti, Heather Raquel" userId="S::hconti@rockets.utoledo.edu::1c655cd8-4db5-4252-b1b1-edb1a2bdeaae" providerId="AD" clId="Web-{FDA977FC-D54B-090C-81AF-0144A439BAFD}" dt="2021-05-18T10:55:30.594" v="26"/>
        <pc:sldMkLst>
          <pc:docMk/>
          <pc:sldMk cId="2786983650" sldId="307"/>
        </pc:sldMkLst>
        <pc:graphicFrameChg chg="mod modGraphic">
          <ac:chgData name="Conti, Heather Raquel" userId="S::hconti@rockets.utoledo.edu::1c655cd8-4db5-4252-b1b1-edb1a2bdeaae" providerId="AD" clId="Web-{FDA977FC-D54B-090C-81AF-0144A439BAFD}" dt="2021-05-18T10:55:30.594" v="26"/>
          <ac:graphicFrameMkLst>
            <pc:docMk/>
            <pc:sldMk cId="2786983650" sldId="307"/>
            <ac:graphicFrameMk id="3" creationId="{F95826C0-860C-45CE-A46B-3138B2775139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Relationship Id="rId2" Type="http://schemas.openxmlformats.org/officeDocument/2006/relationships/image" Target="../media/image6.emf"/><Relationship Id="rId3" Type="http://schemas.openxmlformats.org/officeDocument/2006/relationships/image" Target="../media/image7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8"/>
          </a:xfrm>
          <a:prstGeom prst="rect">
            <a:avLst/>
          </a:prstGeom>
        </p:spPr>
        <p:txBody>
          <a:bodyPr vert="horz" lIns="96656" tIns="48328" rIns="96656" bIns="4832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8" y="0"/>
            <a:ext cx="3169920" cy="481728"/>
          </a:xfrm>
          <a:prstGeom prst="rect">
            <a:avLst/>
          </a:prstGeom>
        </p:spPr>
        <p:txBody>
          <a:bodyPr vert="horz" lIns="96656" tIns="48328" rIns="96656" bIns="48328" rtlCol="0"/>
          <a:lstStyle>
            <a:lvl1pPr algn="r">
              <a:defRPr sz="1200"/>
            </a:lvl1pPr>
          </a:lstStyle>
          <a:p>
            <a:fld id="{3D3E9E76-8342-5349-9FB8-B455A031F01B}" type="datetimeFigureOut">
              <a:rPr lang="en-US" smtClean="0"/>
              <a:t>5/1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5"/>
            <a:ext cx="3169920" cy="481727"/>
          </a:xfrm>
          <a:prstGeom prst="rect">
            <a:avLst/>
          </a:prstGeom>
        </p:spPr>
        <p:txBody>
          <a:bodyPr vert="horz" lIns="96656" tIns="48328" rIns="96656" bIns="4832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8" y="9119475"/>
            <a:ext cx="3169920" cy="481727"/>
          </a:xfrm>
          <a:prstGeom prst="rect">
            <a:avLst/>
          </a:prstGeom>
        </p:spPr>
        <p:txBody>
          <a:bodyPr vert="horz" lIns="96656" tIns="48328" rIns="96656" bIns="48328" rtlCol="0" anchor="b"/>
          <a:lstStyle>
            <a:lvl1pPr algn="r">
              <a:defRPr sz="1200"/>
            </a:lvl1pPr>
          </a:lstStyle>
          <a:p>
            <a:fld id="{46E21FD2-8278-5B47-B8D4-84AAE5672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632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8"/>
          </a:xfrm>
          <a:prstGeom prst="rect">
            <a:avLst/>
          </a:prstGeom>
        </p:spPr>
        <p:txBody>
          <a:bodyPr vert="horz" lIns="96656" tIns="48328" rIns="96656" bIns="4832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8" y="0"/>
            <a:ext cx="3169920" cy="481728"/>
          </a:xfrm>
          <a:prstGeom prst="rect">
            <a:avLst/>
          </a:prstGeom>
        </p:spPr>
        <p:txBody>
          <a:bodyPr vert="horz" lIns="96656" tIns="48328" rIns="96656" bIns="48328" rtlCol="0"/>
          <a:lstStyle>
            <a:lvl1pPr algn="r">
              <a:defRPr sz="1200"/>
            </a:lvl1pPr>
          </a:lstStyle>
          <a:p>
            <a:fld id="{C5E5FA3D-0910-5546-AC48-9EB0ED6428A4}" type="datetimeFigureOut">
              <a:rPr lang="en-US" smtClean="0"/>
              <a:t>5/18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0475" y="1200150"/>
            <a:ext cx="22542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6" tIns="48328" rIns="96656" bIns="4832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2"/>
          </a:xfrm>
          <a:prstGeom prst="rect">
            <a:avLst/>
          </a:prstGeom>
        </p:spPr>
        <p:txBody>
          <a:bodyPr vert="horz" lIns="96656" tIns="48328" rIns="96656" bIns="4832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5"/>
            <a:ext cx="3169920" cy="481727"/>
          </a:xfrm>
          <a:prstGeom prst="rect">
            <a:avLst/>
          </a:prstGeom>
        </p:spPr>
        <p:txBody>
          <a:bodyPr vert="horz" lIns="96656" tIns="48328" rIns="96656" bIns="4832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8" y="9119475"/>
            <a:ext cx="3169920" cy="481727"/>
          </a:xfrm>
          <a:prstGeom prst="rect">
            <a:avLst/>
          </a:prstGeom>
        </p:spPr>
        <p:txBody>
          <a:bodyPr vert="horz" lIns="96656" tIns="48328" rIns="96656" bIns="48328" rtlCol="0" anchor="b"/>
          <a:lstStyle>
            <a:lvl1pPr algn="r">
              <a:defRPr sz="1200"/>
            </a:lvl1pPr>
          </a:lstStyle>
          <a:p>
            <a:fld id="{7AA558A3-E004-414C-BB97-3A24D39EC3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8722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720956"/>
            <a:ext cx="6217920" cy="366098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523125"/>
            <a:ext cx="5486400" cy="2538835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59858"/>
            <a:ext cx="1577340" cy="89114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59858"/>
            <a:ext cx="4640580" cy="89114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621600"/>
            <a:ext cx="6309360" cy="4374197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7037179"/>
            <a:ext cx="6309360" cy="230028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799291"/>
            <a:ext cx="3108960" cy="66720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799291"/>
            <a:ext cx="3108960" cy="66720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59861"/>
            <a:ext cx="6309360" cy="20325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577783"/>
            <a:ext cx="3094672" cy="126333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841115"/>
            <a:ext cx="3094672" cy="56497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577783"/>
            <a:ext cx="3109913" cy="126333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841115"/>
            <a:ext cx="3109913" cy="56497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701040"/>
            <a:ext cx="2359342" cy="245364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514054"/>
            <a:ext cx="3703320" cy="7472892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154680"/>
            <a:ext cx="2359342" cy="5844435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701040"/>
            <a:ext cx="2359342" cy="245364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514054"/>
            <a:ext cx="3703320" cy="7472892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154680"/>
            <a:ext cx="2359342" cy="5844435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59861"/>
            <a:ext cx="6309360" cy="20325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799291"/>
            <a:ext cx="6309360" cy="66720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746406"/>
            <a:ext cx="1645920" cy="5598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E586D-5BAF-DC4F-AAD2-EEC040FA616C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746406"/>
            <a:ext cx="2468880" cy="5598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746406"/>
            <a:ext cx="1645920" cy="5598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A271E-A8EF-5B49-9796-2D52151E64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067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tiff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oleObject" Target="../embeddings/oleObject1.bin"/><Relationship Id="rId6" Type="http://schemas.openxmlformats.org/officeDocument/2006/relationships/image" Target="../media/image5.emf"/><Relationship Id="rId7" Type="http://schemas.openxmlformats.org/officeDocument/2006/relationships/oleObject" Target="../embeddings/oleObject2.bin"/><Relationship Id="rId8" Type="http://schemas.openxmlformats.org/officeDocument/2006/relationships/image" Target="../media/image6.emf"/><Relationship Id="rId9" Type="http://schemas.openxmlformats.org/officeDocument/2006/relationships/oleObject" Target="../embeddings/oleObject3.bin"/><Relationship Id="rId10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264930" y="2876243"/>
            <a:ext cx="3204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/>
              <a:t>B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9BF05C0C-9319-4D25-96CA-2ACD5F75AAE8}"/>
              </a:ext>
            </a:extLst>
          </p:cNvPr>
          <p:cNvSpPr txBox="1"/>
          <p:nvPr/>
        </p:nvSpPr>
        <p:spPr>
          <a:xfrm>
            <a:off x="59713" y="36652"/>
            <a:ext cx="1797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/>
              <a:t>Saul-</a:t>
            </a:r>
            <a:r>
              <a:rPr lang="en-US" sz="1000" b="1" i="1" err="1"/>
              <a:t>McBeth</a:t>
            </a:r>
            <a:r>
              <a:rPr lang="en-US" sz="1000" b="1" i="1"/>
              <a:t> et al. 2020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672" y="4858983"/>
            <a:ext cx="2363317" cy="1219567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807829" y="4599701"/>
            <a:ext cx="320729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/>
              <a:t>D.</a:t>
            </a:r>
          </a:p>
        </p:txBody>
      </p:sp>
      <p:pic>
        <p:nvPicPr>
          <p:cNvPr id="42" name="Picture 41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169844" y="4959274"/>
            <a:ext cx="2261415" cy="1247670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4450316" y="4700514"/>
            <a:ext cx="900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/>
              <a:t>Il17ra</a:t>
            </a:r>
            <a:r>
              <a:rPr lang="en-US" sz="1200" b="1"/>
              <a:t> </a:t>
            </a:r>
            <a:r>
              <a:rPr lang="en-US" sz="1200" b="1" baseline="30000"/>
              <a:t>-/-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26787" y="557263"/>
            <a:ext cx="355738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/>
              <a:t>A. </a:t>
            </a:r>
            <a:endParaRPr lang="en-US"/>
          </a:p>
        </p:txBody>
      </p:sp>
      <p:grpSp>
        <p:nvGrpSpPr>
          <p:cNvPr id="2" name="Group 1"/>
          <p:cNvGrpSpPr/>
          <p:nvPr/>
        </p:nvGrpSpPr>
        <p:grpSpPr>
          <a:xfrm>
            <a:off x="715715" y="3151224"/>
            <a:ext cx="980580" cy="992393"/>
            <a:chOff x="876751" y="1983084"/>
            <a:chExt cx="1625155" cy="1760562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>
              <a:grayscl/>
            </a:blip>
            <a:srcRect t="24924" r="60564" b="24031"/>
            <a:stretch/>
          </p:blipFill>
          <p:spPr>
            <a:xfrm>
              <a:off x="876751" y="1983084"/>
              <a:ext cx="1528549" cy="1760562"/>
            </a:xfrm>
            <a:prstGeom prst="rect">
              <a:avLst/>
            </a:prstGeom>
          </p:spPr>
        </p:pic>
        <p:cxnSp>
          <p:nvCxnSpPr>
            <p:cNvPr id="14" name="Straight Connector 13"/>
            <p:cNvCxnSpPr/>
            <p:nvPr/>
          </p:nvCxnSpPr>
          <p:spPr>
            <a:xfrm>
              <a:off x="1081467" y="2870188"/>
              <a:ext cx="545911" cy="13648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844354" y="2329147"/>
              <a:ext cx="65755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b="1"/>
                <a:t>Proximal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44354" y="2729256"/>
              <a:ext cx="55656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b="1"/>
                <a:t>Medial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44354" y="3113340"/>
              <a:ext cx="48763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b="1"/>
                <a:t>Distal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521D48F-81F2-49AD-8789-64D017A56FC0}"/>
              </a:ext>
            </a:extLst>
          </p:cNvPr>
          <p:cNvSpPr txBox="1"/>
          <p:nvPr/>
        </p:nvSpPr>
        <p:spPr>
          <a:xfrm>
            <a:off x="264930" y="4619824"/>
            <a:ext cx="51435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/>
              <a:t>C.</a:t>
            </a:r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xmlns="" id="{19F197FA-6CE0-4037-AAC0-850CD2813E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4887" y="896973"/>
            <a:ext cx="3239927" cy="210435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1F73872F-2C06-4FC5-A7E4-C4D18B6BB4E2}"/>
              </a:ext>
            </a:extLst>
          </p:cNvPr>
          <p:cNvSpPr txBox="1"/>
          <p:nvPr/>
        </p:nvSpPr>
        <p:spPr>
          <a:xfrm>
            <a:off x="891017" y="4568491"/>
            <a:ext cx="900660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/>
              <a:t>WT</a:t>
            </a:r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81AC2A1C-99F7-4341-ADC1-B55C6E7867F1}"/>
              </a:ext>
            </a:extLst>
          </p:cNvPr>
          <p:cNvSpPr txBox="1"/>
          <p:nvPr/>
        </p:nvSpPr>
        <p:spPr>
          <a:xfrm>
            <a:off x="5662573" y="94492"/>
            <a:ext cx="1797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221266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6">
            <a:extLst>
              <a:ext uri="{FF2B5EF4-FFF2-40B4-BE49-F238E27FC236}">
                <a16:creationId xmlns:a16="http://schemas.microsoft.com/office/drawing/2014/main" xmlns="" id="{74EA4821-CC49-4703-B012-11C64EDE20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700" y="66138"/>
            <a:ext cx="1343025" cy="20955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C1A65C7-F678-40C1-A1EC-EC6EDC0F2282}"/>
              </a:ext>
            </a:extLst>
          </p:cNvPr>
          <p:cNvSpPr txBox="1"/>
          <p:nvPr/>
        </p:nvSpPr>
        <p:spPr>
          <a:xfrm>
            <a:off x="83329" y="494064"/>
            <a:ext cx="3429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b="1"/>
              <a:t>A.</a:t>
            </a:r>
          </a:p>
        </p:txBody>
      </p:sp>
      <p:pic>
        <p:nvPicPr>
          <p:cNvPr id="7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71610786-7566-45CB-825F-79F6294E3D4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256" r="-64" b="305"/>
          <a:stretch/>
        </p:blipFill>
        <p:spPr>
          <a:xfrm>
            <a:off x="426229" y="2985717"/>
            <a:ext cx="5798301" cy="152271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9A0D4520-90BC-494D-9EFE-3B0E0BDC2690}"/>
              </a:ext>
            </a:extLst>
          </p:cNvPr>
          <p:cNvSpPr txBox="1"/>
          <p:nvPr/>
        </p:nvSpPr>
        <p:spPr>
          <a:xfrm>
            <a:off x="83329" y="2652263"/>
            <a:ext cx="3429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b="1">
                <a:cs typeface="Calibri"/>
              </a:rPr>
              <a:t>B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3519EBE4-569D-4CDD-A81B-3D806B71EF5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65306" y="654314"/>
          <a:ext cx="1343025" cy="19414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9" name="Prism 8" r:id="rId5" imgW="2116157" imgH="3059869" progId="Prism8.Document">
                  <p:embed/>
                </p:oleObj>
              </mc:Choice>
              <mc:Fallback>
                <p:oleObj name="Prism 8" r:id="rId5" imgW="2116157" imgH="3059869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xmlns="" id="{3519EBE4-569D-4CDD-A81B-3D806B71EF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5306" y="654314"/>
                        <a:ext cx="1343025" cy="19414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1C9AD11-6A5F-4DEF-97FB-3DFFFCCD384C}"/>
              </a:ext>
            </a:extLst>
          </p:cNvPr>
          <p:cNvSpPr txBox="1"/>
          <p:nvPr/>
        </p:nvSpPr>
        <p:spPr>
          <a:xfrm>
            <a:off x="5662573" y="94492"/>
            <a:ext cx="1797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Supplemental Figure 2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950839F7-7D14-4D0D-B045-E0DDF1130AB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5740" y="4898340"/>
          <a:ext cx="2329970" cy="1713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0" name="Prism 8" r:id="rId7" imgW="4052247" imgH="2982075" progId="Prism8.Document">
                  <p:embed/>
                </p:oleObj>
              </mc:Choice>
              <mc:Fallback>
                <p:oleObj name="Prism 8" r:id="rId7" imgW="4052247" imgH="2982075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xmlns="" id="{950839F7-7D14-4D0D-B045-E0DDF1130A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5740" y="4898340"/>
                        <a:ext cx="2329970" cy="1713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xmlns="" id="{1F64C6BE-2E1E-409E-9805-FFBF0397DFE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85721" y="4759841"/>
          <a:ext cx="2530813" cy="19359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1" name="Prism 8" r:id="rId9" imgW="3896668" imgH="2982075" progId="Prism8.Document">
                  <p:embed/>
                </p:oleObj>
              </mc:Choice>
              <mc:Fallback>
                <p:oleObj name="Prism 8" r:id="rId9" imgW="3896668" imgH="2982075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xmlns="" id="{1F64C6BE-2E1E-409E-9805-FFBF0397DF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85721" y="4759841"/>
                        <a:ext cx="2530813" cy="19359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014FD6F-AC79-4202-A1C3-642C10425D96}"/>
              </a:ext>
            </a:extLst>
          </p:cNvPr>
          <p:cNvSpPr txBox="1"/>
          <p:nvPr/>
        </p:nvSpPr>
        <p:spPr>
          <a:xfrm>
            <a:off x="116250" y="4759841"/>
            <a:ext cx="3429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b="1">
                <a:cs typeface="Calibri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1840551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9BF05C0C-9319-4D25-96CA-2ACD5F75AAE8}"/>
              </a:ext>
            </a:extLst>
          </p:cNvPr>
          <p:cNvSpPr txBox="1"/>
          <p:nvPr/>
        </p:nvSpPr>
        <p:spPr>
          <a:xfrm>
            <a:off x="59713" y="35924"/>
            <a:ext cx="1797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/>
              <a:t>Saul-</a:t>
            </a:r>
            <a:r>
              <a:rPr lang="en-US" sz="1200" b="1" i="1" err="1"/>
              <a:t>McBeth</a:t>
            </a:r>
            <a:r>
              <a:rPr lang="en-US" sz="1200" b="1" i="1"/>
              <a:t> et al. 202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2963" y="519836"/>
            <a:ext cx="3204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/>
              <a:t>A.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0054" y="270725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/>
              <a:t>B.</a:t>
            </a:r>
          </a:p>
        </p:txBody>
      </p:sp>
      <p:grpSp>
        <p:nvGrpSpPr>
          <p:cNvPr id="143" name="Group 142">
            <a:extLst>
              <a:ext uri="{FF2B5EF4-FFF2-40B4-BE49-F238E27FC236}">
                <a16:creationId xmlns:a16="http://schemas.microsoft.com/office/drawing/2014/main" xmlns="" id="{4FE01DAA-8EBF-4621-83FF-CC67115D34C1}"/>
              </a:ext>
            </a:extLst>
          </p:cNvPr>
          <p:cNvGrpSpPr/>
          <p:nvPr/>
        </p:nvGrpSpPr>
        <p:grpSpPr>
          <a:xfrm>
            <a:off x="478539" y="899606"/>
            <a:ext cx="5092647" cy="1824954"/>
            <a:chOff x="298174" y="946459"/>
            <a:chExt cx="6730336" cy="2428516"/>
          </a:xfrm>
        </p:grpSpPr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xmlns="" id="{D7E8827A-4C1A-4231-949E-A785D076C174}"/>
                </a:ext>
              </a:extLst>
            </p:cNvPr>
            <p:cNvSpPr txBox="1"/>
            <p:nvPr/>
          </p:nvSpPr>
          <p:spPr>
            <a:xfrm rot="16200000">
              <a:off x="4855966" y="1632901"/>
              <a:ext cx="908755" cy="366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xmlns="" id="{33FA4DE5-8765-44E7-9069-3A46FFD233A5}"/>
                </a:ext>
              </a:extLst>
            </p:cNvPr>
            <p:cNvSpPr txBox="1"/>
            <p:nvPr/>
          </p:nvSpPr>
          <p:spPr>
            <a:xfrm>
              <a:off x="6064098" y="3006365"/>
              <a:ext cx="908755" cy="3686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200" b="1">
                  <a:latin typeface="Arial"/>
                  <a:cs typeface="Arial"/>
                </a:rPr>
                <a:t>CD11b</a:t>
              </a:r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6" name="Group 145">
              <a:extLst>
                <a:ext uri="{FF2B5EF4-FFF2-40B4-BE49-F238E27FC236}">
                  <a16:creationId xmlns:a16="http://schemas.microsoft.com/office/drawing/2014/main" xmlns="" id="{E84A4AC1-8F8B-45FC-9FE3-A276A51CE95F}"/>
                </a:ext>
              </a:extLst>
            </p:cNvPr>
            <p:cNvGrpSpPr/>
            <p:nvPr/>
          </p:nvGrpSpPr>
          <p:grpSpPr>
            <a:xfrm>
              <a:off x="298174" y="946459"/>
              <a:ext cx="6730336" cy="2340689"/>
              <a:chOff x="298174" y="946459"/>
              <a:chExt cx="6730336" cy="2340689"/>
            </a:xfrm>
          </p:grpSpPr>
          <p:grpSp>
            <p:nvGrpSpPr>
              <p:cNvPr id="147" name="Group 146">
                <a:extLst>
                  <a:ext uri="{FF2B5EF4-FFF2-40B4-BE49-F238E27FC236}">
                    <a16:creationId xmlns:a16="http://schemas.microsoft.com/office/drawing/2014/main" xmlns="" id="{9C42DFB7-BB8A-4CA4-9309-EBF7B5494D4C}"/>
                  </a:ext>
                </a:extLst>
              </p:cNvPr>
              <p:cNvGrpSpPr/>
              <p:nvPr/>
            </p:nvGrpSpPr>
            <p:grpSpPr>
              <a:xfrm>
                <a:off x="298174" y="946459"/>
                <a:ext cx="4635552" cy="2304943"/>
                <a:chOff x="298174" y="946459"/>
                <a:chExt cx="4635552" cy="2304943"/>
              </a:xfrm>
            </p:grpSpPr>
            <p:pic>
              <p:nvPicPr>
                <p:cNvPr id="150" name="Picture 149">
                  <a:extLst>
                    <a:ext uri="{FF2B5EF4-FFF2-40B4-BE49-F238E27FC236}">
                      <a16:creationId xmlns:a16="http://schemas.microsoft.com/office/drawing/2014/main" xmlns="" id="{33D8C29F-E506-4DA3-A2D7-C508DB80DD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biLevel thresh="75000"/>
                </a:blip>
                <a:stretch>
                  <a:fillRect/>
                </a:stretch>
              </p:blipFill>
              <p:spPr>
                <a:xfrm>
                  <a:off x="614958" y="946459"/>
                  <a:ext cx="1895813" cy="1959807"/>
                </a:xfrm>
                <a:prstGeom prst="rect">
                  <a:avLst/>
                </a:prstGeom>
              </p:spPr>
            </p:pic>
            <p:pic>
              <p:nvPicPr>
                <p:cNvPr id="151" name="Picture 150">
                  <a:extLst>
                    <a:ext uri="{FF2B5EF4-FFF2-40B4-BE49-F238E27FC236}">
                      <a16:creationId xmlns:a16="http://schemas.microsoft.com/office/drawing/2014/main" xmlns="" id="{8D59F44D-D76C-45F4-9E31-54FF2B91EB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biLevel thresh="75000"/>
                </a:blip>
                <a:stretch>
                  <a:fillRect/>
                </a:stretch>
              </p:blipFill>
              <p:spPr>
                <a:xfrm>
                  <a:off x="3031927" y="948188"/>
                  <a:ext cx="1901799" cy="2026675"/>
                </a:xfrm>
                <a:prstGeom prst="rect">
                  <a:avLst/>
                </a:prstGeom>
              </p:spPr>
            </p:pic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xmlns="" id="{2FFAF975-4896-4005-9DBF-3DEEC8FE7A66}"/>
                    </a:ext>
                  </a:extLst>
                </p:cNvPr>
                <p:cNvGrpSpPr/>
                <p:nvPr/>
              </p:nvGrpSpPr>
              <p:grpSpPr>
                <a:xfrm>
                  <a:off x="298174" y="1427057"/>
                  <a:ext cx="1768366" cy="1824345"/>
                  <a:chOff x="298174" y="1427057"/>
                  <a:chExt cx="1768366" cy="1824345"/>
                </a:xfrm>
              </p:grpSpPr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xmlns="" id="{C1433225-DDFE-4AB5-85F3-523461DA076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6834" y="1698397"/>
                    <a:ext cx="908755" cy="3660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SC-H</a:t>
                    </a:r>
                  </a:p>
                </p:txBody>
              </p:sp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xmlns="" id="{88D8C6E1-C1C2-4F23-8D57-410FC8FB9C31}"/>
                      </a:ext>
                    </a:extLst>
                  </p:cNvPr>
                  <p:cNvSpPr txBox="1"/>
                  <p:nvPr/>
                </p:nvSpPr>
                <p:spPr>
                  <a:xfrm>
                    <a:off x="1157785" y="2882792"/>
                    <a:ext cx="908755" cy="368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SC-A</a:t>
                    </a:r>
                  </a:p>
                </p:txBody>
              </p:sp>
            </p:grp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xmlns="" id="{3A927646-6F7B-4B3D-87A8-E41ACCA91325}"/>
                    </a:ext>
                  </a:extLst>
                </p:cNvPr>
                <p:cNvSpPr txBox="1"/>
                <p:nvPr/>
              </p:nvSpPr>
              <p:spPr>
                <a:xfrm rot="16200000">
                  <a:off x="2428856" y="1676185"/>
                  <a:ext cx="908755" cy="3660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SSC-A</a:t>
                  </a:r>
                </a:p>
              </p:txBody>
            </p:sp>
            <p:sp>
              <p:nvSpPr>
                <p:cNvPr id="154" name="TextBox 153">
                  <a:extLst>
                    <a:ext uri="{FF2B5EF4-FFF2-40B4-BE49-F238E27FC236}">
                      <a16:creationId xmlns:a16="http://schemas.microsoft.com/office/drawing/2014/main" xmlns="" id="{5CEA9FC6-D2AE-47F3-A3FA-6CE55DFC5C4D}"/>
                    </a:ext>
                  </a:extLst>
                </p:cNvPr>
                <p:cNvSpPr txBox="1"/>
                <p:nvPr/>
              </p:nvSpPr>
              <p:spPr>
                <a:xfrm>
                  <a:off x="3690264" y="2809827"/>
                  <a:ext cx="908755" cy="368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SC-A</a:t>
                  </a:r>
                </a:p>
              </p:txBody>
            </p:sp>
          </p:grp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xmlns="" id="{B33FD22D-2E79-4BBF-8B7B-A17E11E9BFA4}"/>
                  </a:ext>
                </a:extLst>
              </p:cNvPr>
              <p:cNvSpPr txBox="1"/>
              <p:nvPr/>
            </p:nvSpPr>
            <p:spPr>
              <a:xfrm>
                <a:off x="6119755" y="2918538"/>
                <a:ext cx="908755" cy="368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r>
                  <a:rPr lang="en-US" sz="1200" b="1">
                    <a:latin typeface="Arial"/>
                    <a:cs typeface="Arial"/>
                  </a:rPr>
                  <a:t>CD11b</a:t>
                </a:r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xmlns="" id="{BADB5393-6FDF-4C7C-9EC9-1606536FAFE0}"/>
                  </a:ext>
                </a:extLst>
              </p:cNvPr>
              <p:cNvSpPr txBox="1"/>
              <p:nvPr/>
            </p:nvSpPr>
            <p:spPr>
              <a:xfrm rot="16200000">
                <a:off x="4912291" y="1578585"/>
                <a:ext cx="908755" cy="3660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R-1</a:t>
                </a:r>
              </a:p>
            </p:txBody>
          </p:sp>
        </p:grpSp>
      </p:grpSp>
      <p:pic>
        <p:nvPicPr>
          <p:cNvPr id="157" name="Picture 156">
            <a:extLst>
              <a:ext uri="{FF2B5EF4-FFF2-40B4-BE49-F238E27FC236}">
                <a16:creationId xmlns:a16="http://schemas.microsoft.com/office/drawing/2014/main" xmlns="" id="{9830AD9A-D91A-441E-89F1-1870F25092E5}"/>
              </a:ext>
            </a:extLst>
          </p:cNvPr>
          <p:cNvPicPr>
            <a:picLocks noChangeAspect="1"/>
          </p:cNvPicPr>
          <p:nvPr/>
        </p:nvPicPr>
        <p:blipFill>
          <a:blip r:embed="rId4">
            <a:biLevel thresh="75000"/>
          </a:blip>
          <a:stretch>
            <a:fillRect/>
          </a:stretch>
        </p:blipFill>
        <p:spPr>
          <a:xfrm>
            <a:off x="4452100" y="811223"/>
            <a:ext cx="1439027" cy="1571228"/>
          </a:xfrm>
          <a:prstGeom prst="rect">
            <a:avLst/>
          </a:prstGeom>
        </p:spPr>
      </p:pic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xmlns="" id="{2EF12072-BF17-4344-B8EC-C20BA4053D30}"/>
              </a:ext>
            </a:extLst>
          </p:cNvPr>
          <p:cNvCxnSpPr>
            <a:cxnSpLocks/>
          </p:cNvCxnSpPr>
          <p:nvPr/>
        </p:nvCxnSpPr>
        <p:spPr>
          <a:xfrm>
            <a:off x="2110104" y="1066948"/>
            <a:ext cx="32797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Arrow Connector 160">
            <a:extLst>
              <a:ext uri="{FF2B5EF4-FFF2-40B4-BE49-F238E27FC236}">
                <a16:creationId xmlns:a16="http://schemas.microsoft.com/office/drawing/2014/main" xmlns="" id="{2D7FE28F-05EB-416F-B9DC-866AEED793E4}"/>
              </a:ext>
            </a:extLst>
          </p:cNvPr>
          <p:cNvCxnSpPr>
            <a:cxnSpLocks/>
          </p:cNvCxnSpPr>
          <p:nvPr/>
        </p:nvCxnSpPr>
        <p:spPr>
          <a:xfrm>
            <a:off x="3967537" y="1058847"/>
            <a:ext cx="32797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xmlns="" id="{1C626A9E-FD48-43B5-BE57-94CD4196CF39}"/>
              </a:ext>
            </a:extLst>
          </p:cNvPr>
          <p:cNvCxnSpPr>
            <a:cxnSpLocks/>
          </p:cNvCxnSpPr>
          <p:nvPr/>
        </p:nvCxnSpPr>
        <p:spPr>
          <a:xfrm>
            <a:off x="2719722" y="3602226"/>
            <a:ext cx="63218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3" name="Picture 172">
            <a:extLst>
              <a:ext uri="{FF2B5EF4-FFF2-40B4-BE49-F238E27FC236}">
                <a16:creationId xmlns:a16="http://schemas.microsoft.com/office/drawing/2014/main" xmlns="" id="{AD1DC118-D656-45DA-B418-F277DADC829D}"/>
              </a:ext>
            </a:extLst>
          </p:cNvPr>
          <p:cNvPicPr>
            <a:picLocks noChangeAspect="1"/>
          </p:cNvPicPr>
          <p:nvPr/>
        </p:nvPicPr>
        <p:blipFill>
          <a:blip r:embed="rId5">
            <a:biLevel thresh="75000"/>
          </a:blip>
          <a:stretch>
            <a:fillRect/>
          </a:stretch>
        </p:blipFill>
        <p:spPr>
          <a:xfrm>
            <a:off x="717614" y="2878386"/>
            <a:ext cx="1912624" cy="1935348"/>
          </a:xfrm>
          <a:prstGeom prst="rect">
            <a:avLst/>
          </a:prstGeom>
        </p:spPr>
      </p:pic>
      <p:pic>
        <p:nvPicPr>
          <p:cNvPr id="174" name="Picture 173">
            <a:extLst>
              <a:ext uri="{FF2B5EF4-FFF2-40B4-BE49-F238E27FC236}">
                <a16:creationId xmlns:a16="http://schemas.microsoft.com/office/drawing/2014/main" xmlns="" id="{F61309C8-0F0D-4FFD-9081-E4489D16DD67}"/>
              </a:ext>
            </a:extLst>
          </p:cNvPr>
          <p:cNvPicPr>
            <a:picLocks noChangeAspect="1"/>
          </p:cNvPicPr>
          <p:nvPr/>
        </p:nvPicPr>
        <p:blipFill>
          <a:blip r:embed="rId6">
            <a:biLevel thresh="75000"/>
          </a:blip>
          <a:stretch>
            <a:fillRect/>
          </a:stretch>
        </p:blipFill>
        <p:spPr>
          <a:xfrm>
            <a:off x="3401865" y="2878386"/>
            <a:ext cx="2008382" cy="2071977"/>
          </a:xfrm>
          <a:prstGeom prst="rect">
            <a:avLst/>
          </a:prstGeom>
        </p:spPr>
      </p:pic>
      <p:sp>
        <p:nvSpPr>
          <p:cNvPr id="175" name="TextBox 174">
            <a:extLst>
              <a:ext uri="{FF2B5EF4-FFF2-40B4-BE49-F238E27FC236}">
                <a16:creationId xmlns:a16="http://schemas.microsoft.com/office/drawing/2014/main" xmlns="" id="{8F1943CE-F120-4795-9B66-154BE33B6726}"/>
              </a:ext>
            </a:extLst>
          </p:cNvPr>
          <p:cNvSpPr txBox="1"/>
          <p:nvPr/>
        </p:nvSpPr>
        <p:spPr>
          <a:xfrm rot="16200000">
            <a:off x="110306" y="3463727"/>
            <a:ext cx="937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70ACA2E5-B1AF-4B2A-BAEB-FEBED3D5B951}"/>
              </a:ext>
            </a:extLst>
          </p:cNvPr>
          <p:cNvSpPr txBox="1"/>
          <p:nvPr/>
        </p:nvSpPr>
        <p:spPr>
          <a:xfrm rot="16200000">
            <a:off x="3167768" y="3672843"/>
            <a:ext cx="418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BC47E42B-4927-4418-9404-434D81F8FF74}"/>
              </a:ext>
            </a:extLst>
          </p:cNvPr>
          <p:cNvSpPr txBox="1"/>
          <p:nvPr/>
        </p:nvSpPr>
        <p:spPr>
          <a:xfrm>
            <a:off x="1372872" y="4813734"/>
            <a:ext cx="1173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xmlns="" id="{4B1270CC-9853-484D-8A00-319FB3098589}"/>
              </a:ext>
            </a:extLst>
          </p:cNvPr>
          <p:cNvSpPr txBox="1"/>
          <p:nvPr/>
        </p:nvSpPr>
        <p:spPr>
          <a:xfrm>
            <a:off x="4005740" y="4889111"/>
            <a:ext cx="1258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65C28DF5-74E0-4181-8F9D-D02621F2E42B}"/>
              </a:ext>
            </a:extLst>
          </p:cNvPr>
          <p:cNvSpPr txBox="1"/>
          <p:nvPr/>
        </p:nvSpPr>
        <p:spPr>
          <a:xfrm>
            <a:off x="5662573" y="94492"/>
            <a:ext cx="1797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18637559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18C37FE8-F0AF-B341-BB8A-47679E5659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0981158"/>
              </p:ext>
            </p:extLst>
          </p:nvPr>
        </p:nvGraphicFramePr>
        <p:xfrm>
          <a:off x="502920" y="2782411"/>
          <a:ext cx="5715000" cy="2429128"/>
        </p:xfrm>
        <a:graphic>
          <a:graphicData uri="http://schemas.openxmlformats.org/drawingml/2006/table">
            <a:tbl>
              <a:tblPr firstRow="1" firstCol="1" bandRow="1">
                <a:tableStyleId>{0505E3EF-67EA-436B-97B2-0124C06EBD24}</a:tableStyleId>
              </a:tblPr>
              <a:tblGrid>
                <a:gridCol w="877375">
                  <a:extLst>
                    <a:ext uri="{9D8B030D-6E8A-4147-A177-3AD203B41FA5}">
                      <a16:colId xmlns:a16="http://schemas.microsoft.com/office/drawing/2014/main" xmlns="" val="2366255097"/>
                    </a:ext>
                  </a:extLst>
                </a:gridCol>
                <a:gridCol w="2380721">
                  <a:extLst>
                    <a:ext uri="{9D8B030D-6E8A-4147-A177-3AD203B41FA5}">
                      <a16:colId xmlns:a16="http://schemas.microsoft.com/office/drawing/2014/main" xmlns="" val="23021173"/>
                    </a:ext>
                  </a:extLst>
                </a:gridCol>
                <a:gridCol w="2456904">
                  <a:extLst>
                    <a:ext uri="{9D8B030D-6E8A-4147-A177-3AD203B41FA5}">
                      <a16:colId xmlns:a16="http://schemas.microsoft.com/office/drawing/2014/main" xmlns="" val="4160095757"/>
                    </a:ext>
                  </a:extLst>
                </a:gridCol>
              </a:tblGrid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en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orward (5’ – 3’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verse (5’-3’)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56369232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Krt1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GATGGATTTGGTGGTGGTTT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TTCTCCTGGGTGGCAATA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526364075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dc3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TGAAAGAGCTGAGCGAAGT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TGGCTTCCTCCTTGGTAAAC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481552936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l2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TCAACACAGATGAGTTGGGG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TTGTGATGTCATCCTGAGT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00244043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err="1">
                          <a:effectLst/>
                        </a:rPr>
                        <a:t>Kgf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AGCGACACACCAGAAGTTAT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CACTTTCCACCCCTTTGATT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959158287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err="1">
                          <a:effectLst/>
                        </a:rPr>
                        <a:t>Egf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CAAAACAGGGTACGTCTTC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AGACACATTTTCCCATCCC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724356577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mp1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GGATCCACACTCTCGGTTTT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ACACAGCATCAACTTGTGGC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516038647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l2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TCAACACAGATGAGTTGGGG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TTGTGATGTCATCCTGAGT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13298537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imp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GACCACCTTATACCAGCGTTA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CACTGATGTGCAAATTTCCGT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4528275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imp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GCTGGACGTTGGAGGAAAGA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TGGTGCCCATTGATGCTCTT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4272895221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imp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GCCTCAAGCTAGAAGTCAACA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AGGTCACAAAACAAGGCAAGT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450731425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imp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ATCCAGTGAGAAGGTAGTCCC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r>
                        <a:rPr lang="en-US" sz="1000" kern="1200">
                          <a:effectLst/>
                        </a:rPr>
                        <a:t>GGCCAGTCAAAAGATACTGCT</a:t>
                      </a:r>
                      <a:endParaRPr lang="en-US" sz="1000">
                        <a:effectLst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47488111"/>
                  </a:ext>
                </a:extLst>
              </a:tr>
              <a:tr h="18685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sf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CATCAAAGAAGCCCTGAAC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TGTCTGGTAGTAGCTGGCTG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440907235"/>
                  </a:ext>
                </a:extLst>
              </a:tr>
            </a:tbl>
          </a:graphicData>
        </a:graphic>
      </p:graphicFrame>
      <p:sp>
        <p:nvSpPr>
          <p:cNvPr id="7" name="Rectangle 1">
            <a:extLst>
              <a:ext uri="{FF2B5EF4-FFF2-40B4-BE49-F238E27FC236}">
                <a16:creationId xmlns:a16="http://schemas.microsoft.com/office/drawing/2014/main" xmlns="" id="{A1BC9187-2EDF-9446-BAA8-2C1E2CFE15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0100" y="3163888"/>
            <a:ext cx="73152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BF05C0C-9319-4D25-96CA-2ACD5F75AAE8}"/>
              </a:ext>
            </a:extLst>
          </p:cNvPr>
          <p:cNvSpPr txBox="1"/>
          <p:nvPr/>
        </p:nvSpPr>
        <p:spPr>
          <a:xfrm>
            <a:off x="59713" y="35924"/>
            <a:ext cx="1797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/>
              <a:t>Saul-McBeth et al. 20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F84EE54-500F-1741-8410-E1E558FE0F6B}"/>
              </a:ext>
            </a:extLst>
          </p:cNvPr>
          <p:cNvSpPr txBox="1"/>
          <p:nvPr/>
        </p:nvSpPr>
        <p:spPr>
          <a:xfrm>
            <a:off x="399503" y="1521468"/>
            <a:ext cx="5137351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000" b="1"/>
              <a:t>Supplemental Table I</a:t>
            </a:r>
            <a:r>
              <a:rPr lang="en-US" sz="1000"/>
              <a:t>. In-house designed primer sequences for quantitative PCR  ​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5626C54-69E7-4FC0-9B95-59F10617F092}"/>
              </a:ext>
            </a:extLst>
          </p:cNvPr>
          <p:cNvSpPr txBox="1"/>
          <p:nvPr/>
        </p:nvSpPr>
        <p:spPr>
          <a:xfrm>
            <a:off x="5662573" y="94492"/>
            <a:ext cx="1797618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/>
              <a:t>Supplemental Table I</a:t>
            </a:r>
          </a:p>
        </p:txBody>
      </p:sp>
    </p:spTree>
    <p:extLst>
      <p:ext uri="{BB962C8B-B14F-4D97-AF65-F5344CB8AC3E}">
        <p14:creationId xmlns:p14="http://schemas.microsoft.com/office/powerpoint/2010/main" val="25329210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BF05C0C-9319-4D25-96CA-2ACD5F75AAE8}"/>
              </a:ext>
            </a:extLst>
          </p:cNvPr>
          <p:cNvSpPr txBox="1"/>
          <p:nvPr/>
        </p:nvSpPr>
        <p:spPr>
          <a:xfrm>
            <a:off x="59713" y="35924"/>
            <a:ext cx="1797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/>
              <a:t>Saul-McBeth et al. 20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F84EE54-500F-1741-8410-E1E558FE0F6B}"/>
              </a:ext>
            </a:extLst>
          </p:cNvPr>
          <p:cNvSpPr txBox="1"/>
          <p:nvPr/>
        </p:nvSpPr>
        <p:spPr>
          <a:xfrm>
            <a:off x="193026" y="1353685"/>
            <a:ext cx="5137351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000" b="1"/>
              <a:t>Supplemental Table II</a:t>
            </a:r>
            <a:r>
              <a:rPr lang="en-US" sz="1000"/>
              <a:t>. Isotype control antibodies ​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5626C54-69E7-4FC0-9B95-59F10617F092}"/>
              </a:ext>
            </a:extLst>
          </p:cNvPr>
          <p:cNvSpPr txBox="1"/>
          <p:nvPr/>
        </p:nvSpPr>
        <p:spPr>
          <a:xfrm>
            <a:off x="5662573" y="94492"/>
            <a:ext cx="1797618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/>
              <a:t>Supplemental Table II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xmlns="" id="{F95826C0-860C-45CE-A46B-3138B27751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5835343"/>
              </p:ext>
            </p:extLst>
          </p:nvPr>
        </p:nvGraphicFramePr>
        <p:xfrm>
          <a:off x="600229" y="1856758"/>
          <a:ext cx="5937250" cy="11734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254125">
                  <a:extLst>
                    <a:ext uri="{9D8B030D-6E8A-4147-A177-3AD203B41FA5}">
                      <a16:colId xmlns:a16="http://schemas.microsoft.com/office/drawing/2014/main" xmlns="" val="350444802"/>
                    </a:ext>
                  </a:extLst>
                </a:gridCol>
                <a:gridCol w="1572260">
                  <a:extLst>
                    <a:ext uri="{9D8B030D-6E8A-4147-A177-3AD203B41FA5}">
                      <a16:colId xmlns:a16="http://schemas.microsoft.com/office/drawing/2014/main" xmlns="" val="3955786409"/>
                    </a:ext>
                  </a:extLst>
                </a:gridCol>
                <a:gridCol w="1609090">
                  <a:extLst>
                    <a:ext uri="{9D8B030D-6E8A-4147-A177-3AD203B41FA5}">
                      <a16:colId xmlns:a16="http://schemas.microsoft.com/office/drawing/2014/main" xmlns="" val="1792116896"/>
                    </a:ext>
                  </a:extLst>
                </a:gridCol>
                <a:gridCol w="1501775">
                  <a:extLst>
                    <a:ext uri="{9D8B030D-6E8A-4147-A177-3AD203B41FA5}">
                      <a16:colId xmlns:a16="http://schemas.microsoft.com/office/drawing/2014/main" xmlns="" val="132956871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able I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32526092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ontrol antibody isotype</a:t>
                      </a:r>
                      <a:r>
                        <a:rPr lang="en-US" sz="1100" baseline="30000">
                          <a:effectLst/>
                        </a:rPr>
                        <a:t>€</a:t>
                      </a: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Neutralizing antibody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ose amount (</a:t>
                      </a:r>
                      <a:r>
                        <a:rPr lang="en-US" sz="1100" err="1">
                          <a:effectLst/>
                        </a:rPr>
                        <a:t>i.p.</a:t>
                      </a:r>
                      <a:r>
                        <a:rPr lang="en-US" sz="1100">
                          <a:effectLst/>
                        </a:rPr>
                        <a:t>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osing schedule</a:t>
                      </a:r>
                      <a:r>
                        <a:rPr lang="en-US" sz="1100" baseline="30000">
                          <a:effectLst/>
                        </a:rPr>
                        <a:t>*</a:t>
                      </a: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4126232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ouse IgG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-IL-17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100">
                          <a:effectLst/>
                        </a:rPr>
                        <a:t>150 μ</a:t>
                      </a:r>
                      <a:r>
                        <a:rPr lang="en-US" sz="1100">
                          <a:effectLst/>
                        </a:rPr>
                        <a:t>g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8 and D1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25591708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Hamster IgG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-IL-1R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100">
                          <a:effectLst/>
                        </a:rPr>
                        <a:t>300 μ</a:t>
                      </a:r>
                      <a:r>
                        <a:rPr lang="en-US" sz="1100">
                          <a:effectLst/>
                        </a:rPr>
                        <a:t>g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0, D2, D4, D6, D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22252135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at IgG2a</a:t>
                      </a:r>
                      <a:r>
                        <a:rPr lang="en-US" sz="1100" baseline="30000">
                          <a:effectLst/>
                        </a:rPr>
                        <a:t>#</a:t>
                      </a: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-Ly6G</a:t>
                      </a:r>
                      <a:r>
                        <a:rPr lang="en-US" sz="1100" baseline="30000">
                          <a:effectLst/>
                        </a:rPr>
                        <a:t>@</a:t>
                      </a: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100">
                          <a:effectLst/>
                        </a:rPr>
                        <a:t>150 μ</a:t>
                      </a:r>
                      <a:r>
                        <a:rPr lang="en-US" sz="1100">
                          <a:effectLst/>
                        </a:rPr>
                        <a:t>g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24243732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Goat IgG</a:t>
                      </a:r>
                      <a:r>
                        <a:rPr lang="en-US" sz="1100" baseline="30000">
                          <a:effectLst/>
                        </a:rPr>
                        <a:t>#</a:t>
                      </a: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-G-CSF</a:t>
                      </a:r>
                      <a:r>
                        <a:rPr lang="en-US" sz="1100" baseline="30000">
                          <a:effectLst/>
                        </a:rPr>
                        <a:t>@</a:t>
                      </a:r>
                      <a:endParaRPr lang="en-US" sz="110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100">
                          <a:effectLst/>
                        </a:rPr>
                        <a:t>10 μ</a:t>
                      </a:r>
                      <a:r>
                        <a:rPr lang="en-US" sz="1100">
                          <a:effectLst/>
                        </a:rPr>
                        <a:t>g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7, D8, D9, D1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64993103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0C37392C-B45D-40C8-A45D-41E42449897F}"/>
              </a:ext>
            </a:extLst>
          </p:cNvPr>
          <p:cNvSpPr txBox="1"/>
          <p:nvPr/>
        </p:nvSpPr>
        <p:spPr>
          <a:xfrm>
            <a:off x="675895" y="3140322"/>
            <a:ext cx="5583069" cy="110799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endParaRPr lang="en-US" sz="1100">
              <a:cs typeface="Calibri"/>
            </a:endParaRPr>
          </a:p>
          <a:p>
            <a:r>
              <a:rPr lang="en-US" sz="1100">
                <a:cs typeface="Calibri"/>
              </a:rPr>
              <a:t>€ The isotype control antibodies used were recommended by the neutralizing antibody manufacturers.</a:t>
            </a:r>
          </a:p>
          <a:p>
            <a:r>
              <a:rPr lang="en-US" sz="1100">
                <a:cs typeface="Calibri"/>
              </a:rPr>
              <a:t>* Day of administration relative to Day 0 when mice were irradiated.</a:t>
            </a:r>
          </a:p>
          <a:p>
            <a:r>
              <a:rPr lang="en-US" sz="1100">
                <a:cs typeface="Calibri"/>
              </a:rPr>
              <a:t># Administered together to the same mice.</a:t>
            </a:r>
          </a:p>
          <a:p>
            <a:r>
              <a:rPr lang="en-US" sz="1100">
                <a:cs typeface="Calibri"/>
              </a:rPr>
              <a:t>@ Administered together to the same mice.</a:t>
            </a:r>
          </a:p>
        </p:txBody>
      </p:sp>
    </p:spTree>
    <p:extLst>
      <p:ext uri="{BB962C8B-B14F-4D97-AF65-F5344CB8AC3E}">
        <p14:creationId xmlns:p14="http://schemas.microsoft.com/office/powerpoint/2010/main" val="2786983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19D1C4D7627E34EA4B8661BE52F49B6" ma:contentTypeVersion="13" ma:contentTypeDescription="Create a new document." ma:contentTypeScope="" ma:versionID="b5e47041ff1f59e33d6ec52a20b3e1d0">
  <xsd:schema xmlns:xsd="http://www.w3.org/2001/XMLSchema" xmlns:xs="http://www.w3.org/2001/XMLSchema" xmlns:p="http://schemas.microsoft.com/office/2006/metadata/properties" xmlns:ns3="7190521a-0f37-46f5-8ccc-9336be57d474" xmlns:ns4="f43b7408-c7d8-4c73-b824-3ebf1925ccf2" targetNamespace="http://schemas.microsoft.com/office/2006/metadata/properties" ma:root="true" ma:fieldsID="396568c79f9dc65670505501026ba6c0" ns3:_="" ns4:_="">
    <xsd:import namespace="7190521a-0f37-46f5-8ccc-9336be57d474"/>
    <xsd:import namespace="f43b7408-c7d8-4c73-b824-3ebf1925ccf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190521a-0f37-46f5-8ccc-9336be57d47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43b7408-c7d8-4c73-b824-3ebf1925ccf2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63A9A56-CC73-4B92-A689-62E29B1C8FFF}">
  <ds:schemaRefs>
    <ds:schemaRef ds:uri="7190521a-0f37-46f5-8ccc-9336be57d474"/>
    <ds:schemaRef ds:uri="f43b7408-c7d8-4c73-b824-3ebf1925ccf2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FD342D10-E8A6-4A1A-AA60-685517FE38A6}">
  <ds:schemaRefs>
    <ds:schemaRef ds:uri="http://purl.org/dc/elements/1.1/"/>
    <ds:schemaRef ds:uri="f43b7408-c7d8-4c73-b824-3ebf1925ccf2"/>
    <ds:schemaRef ds:uri="http://schemas.microsoft.com/office/2006/metadata/properties"/>
    <ds:schemaRef ds:uri="http://schemas.openxmlformats.org/package/2006/metadata/core-properties"/>
    <ds:schemaRef ds:uri="http://schemas.microsoft.com/office/infopath/2007/PartnerControls"/>
    <ds:schemaRef ds:uri="http://schemas.microsoft.com/office/2006/documentManagement/types"/>
    <ds:schemaRef ds:uri="http://purl.org/dc/dcmitype/"/>
    <ds:schemaRef ds:uri="7190521a-0f37-46f5-8ccc-9336be57d474"/>
    <ds:schemaRef ds:uri="http://www.w3.org/XML/1998/namespace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F27B06F7-2FD5-43B0-897D-22029E42149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4</Words>
  <Application>Microsoft Macintosh PowerPoint</Application>
  <PresentationFormat>Custom</PresentationFormat>
  <Paragraphs>102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Calibri</vt:lpstr>
      <vt:lpstr>Calibri Light</vt:lpstr>
      <vt:lpstr>Arial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Conti, Heather Raquel</cp:lastModifiedBy>
  <cp:revision>1</cp:revision>
  <cp:lastPrinted>2021-03-29T16:31:40Z</cp:lastPrinted>
  <dcterms:created xsi:type="dcterms:W3CDTF">2020-01-07T19:40:21Z</dcterms:created>
  <dcterms:modified xsi:type="dcterms:W3CDTF">2021-05-18T16:46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19D1C4D7627E34EA4B8661BE52F49B6</vt:lpwstr>
  </property>
</Properties>
</file>